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074" autoAdjust="0"/>
    <p:restoredTop sz="94510" autoAdjust="0"/>
  </p:normalViewPr>
  <p:slideViewPr>
    <p:cSldViewPr>
      <p:cViewPr varScale="1">
        <p:scale>
          <a:sx n="106" d="100"/>
          <a:sy n="106" d="100"/>
        </p:scale>
        <p:origin x="2424" y="16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5924-7EEE-45D6-B492-1286ECE42C20}" type="datetimeFigureOut">
              <a:rPr lang="en-US" smtClean="0"/>
              <a:t>8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16124-2225-490E-991F-399C08136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779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5924-7EEE-45D6-B492-1286ECE42C20}" type="datetimeFigureOut">
              <a:rPr lang="en-US" smtClean="0"/>
              <a:t>8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16124-2225-490E-991F-399C08136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725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5924-7EEE-45D6-B492-1286ECE42C20}" type="datetimeFigureOut">
              <a:rPr lang="en-US" smtClean="0"/>
              <a:t>8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16124-2225-490E-991F-399C08136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80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5924-7EEE-45D6-B492-1286ECE42C20}" type="datetimeFigureOut">
              <a:rPr lang="en-US" smtClean="0"/>
              <a:t>8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16124-2225-490E-991F-399C08136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727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5924-7EEE-45D6-B492-1286ECE42C20}" type="datetimeFigureOut">
              <a:rPr lang="en-US" smtClean="0"/>
              <a:t>8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16124-2225-490E-991F-399C08136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811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5924-7EEE-45D6-B492-1286ECE42C20}" type="datetimeFigureOut">
              <a:rPr lang="en-US" smtClean="0"/>
              <a:t>8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16124-2225-490E-991F-399C08136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941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5924-7EEE-45D6-B492-1286ECE42C20}" type="datetimeFigureOut">
              <a:rPr lang="en-US" smtClean="0"/>
              <a:t>8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16124-2225-490E-991F-399C08136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688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5924-7EEE-45D6-B492-1286ECE42C20}" type="datetimeFigureOut">
              <a:rPr lang="en-US" smtClean="0"/>
              <a:t>8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16124-2225-490E-991F-399C08136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137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5924-7EEE-45D6-B492-1286ECE42C20}" type="datetimeFigureOut">
              <a:rPr lang="en-US" smtClean="0"/>
              <a:t>8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16124-2225-490E-991F-399C08136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554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5924-7EEE-45D6-B492-1286ECE42C20}" type="datetimeFigureOut">
              <a:rPr lang="en-US" smtClean="0"/>
              <a:t>8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16124-2225-490E-991F-399C08136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053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5924-7EEE-45D6-B492-1286ECE42C20}" type="datetimeFigureOut">
              <a:rPr lang="en-US" smtClean="0"/>
              <a:t>8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16124-2225-490E-991F-399C08136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076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115924-7EEE-45D6-B492-1286ECE42C20}" type="datetimeFigureOut">
              <a:rPr lang="en-US" smtClean="0"/>
              <a:t>8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516124-2225-490E-991F-399C08136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478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A74DD93-E4FC-D14A-916D-AE3D41724792}"/>
              </a:ext>
            </a:extLst>
          </p:cNvPr>
          <p:cNvGrpSpPr/>
          <p:nvPr/>
        </p:nvGrpSpPr>
        <p:grpSpPr>
          <a:xfrm>
            <a:off x="914400" y="914400"/>
            <a:ext cx="5181600" cy="4593965"/>
            <a:chOff x="609601" y="646957"/>
            <a:chExt cx="5181600" cy="4593965"/>
          </a:xfrm>
        </p:grpSpPr>
        <p:sp>
          <p:nvSpPr>
            <p:cNvPr id="5" name="TextBox 4"/>
            <p:cNvSpPr txBox="1"/>
            <p:nvPr/>
          </p:nvSpPr>
          <p:spPr>
            <a:xfrm>
              <a:off x="609601" y="646957"/>
              <a:ext cx="5177798" cy="83099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287 patients &gt;18 years of age with primary ovarian tumors who underwent staging and/or cytoreductive surgery at the VUMC between 1/1/1994 and 12/31/2004​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427452" y="2743200"/>
              <a:ext cx="3683526" cy="3385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- 12 Non-epithelial tumors 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427452" y="2286000"/>
              <a:ext cx="3683526" cy="3385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- 4 Non-ovarian tissue samples </a:t>
              </a:r>
            </a:p>
          </p:txBody>
        </p:sp>
        <p:cxnSp>
          <p:nvCxnSpPr>
            <p:cNvPr id="26" name="Straight Arrow Connector 25"/>
            <p:cNvCxnSpPr>
              <a:cxnSpLocks/>
            </p:cNvCxnSpPr>
            <p:nvPr/>
          </p:nvCxnSpPr>
          <p:spPr>
            <a:xfrm>
              <a:off x="967099" y="1488564"/>
              <a:ext cx="7847" cy="220087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1427451" y="1600200"/>
              <a:ext cx="3683527" cy="5847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- 3 No formalin-fixed paraffin-embedded   </a:t>
              </a:r>
            </a:p>
            <a:p>
              <a:r>
                <a:rPr lang="en-US" sz="1600" dirty="0"/>
                <a:t>      tissue blocks available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D851D45-3CDD-804D-815D-7DD98C0121C7}"/>
                </a:ext>
              </a:extLst>
            </p:cNvPr>
            <p:cNvSpPr txBox="1"/>
            <p:nvPr/>
          </p:nvSpPr>
          <p:spPr>
            <a:xfrm>
              <a:off x="613403" y="3700045"/>
              <a:ext cx="5177797" cy="3385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206 Epithelial ovarian tumors on our tissue microarray 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0C44A04-FA3B-0649-B562-69F9E9E2A0AE}"/>
                </a:ext>
              </a:extLst>
            </p:cNvPr>
            <p:cNvSpPr txBox="1"/>
            <p:nvPr/>
          </p:nvSpPr>
          <p:spPr>
            <a:xfrm>
              <a:off x="1427451" y="3200400"/>
              <a:ext cx="3684527" cy="3385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- 62 blocks with &lt;80% tumor cells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E02994C-70C3-8149-8C15-10A594D31753}"/>
                </a:ext>
              </a:extLst>
            </p:cNvPr>
            <p:cNvSpPr txBox="1"/>
            <p:nvPr/>
          </p:nvSpPr>
          <p:spPr>
            <a:xfrm>
              <a:off x="609601" y="4656147"/>
              <a:ext cx="5181600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196 Epithelial ovarian tumor tissue samples stained and quantified for NF-kB transcription factors (p65 and p52)</a:t>
              </a: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7E718BC2-1EDC-EA4D-8847-866379A2F1FC}"/>
                </a:ext>
              </a:extLst>
            </p:cNvPr>
            <p:cNvCxnSpPr>
              <a:cxnSpLocks/>
            </p:cNvCxnSpPr>
            <p:nvPr/>
          </p:nvCxnSpPr>
          <p:spPr>
            <a:xfrm>
              <a:off x="967099" y="4038599"/>
              <a:ext cx="0" cy="61754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9A885D77-942C-A742-89D8-868CFFF78F78}"/>
                </a:ext>
              </a:extLst>
            </p:cNvPr>
            <p:cNvCxnSpPr>
              <a:cxnSpLocks/>
              <a:endCxn id="33" idx="1"/>
            </p:cNvCxnSpPr>
            <p:nvPr/>
          </p:nvCxnSpPr>
          <p:spPr>
            <a:xfrm>
              <a:off x="981526" y="3369677"/>
              <a:ext cx="44592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C074766-1125-1B46-A4E3-547B71DBCC22}"/>
                </a:ext>
              </a:extLst>
            </p:cNvPr>
            <p:cNvSpPr txBox="1"/>
            <p:nvPr/>
          </p:nvSpPr>
          <p:spPr>
            <a:xfrm>
              <a:off x="1427451" y="4185079"/>
              <a:ext cx="4363749" cy="3385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- 10 samples with &lt;100 tumor cell nuclei per core</a:t>
              </a:r>
            </a:p>
          </p:txBody>
        </p: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E90864A0-4971-0745-AEC9-050CF89D479A}"/>
                </a:ext>
              </a:extLst>
            </p:cNvPr>
            <p:cNvCxnSpPr>
              <a:cxnSpLocks/>
              <a:endCxn id="25" idx="1"/>
            </p:cNvCxnSpPr>
            <p:nvPr/>
          </p:nvCxnSpPr>
          <p:spPr>
            <a:xfrm>
              <a:off x="981526" y="4354356"/>
              <a:ext cx="44592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11D84624-D3A5-4D41-92D0-30B8E230F8C7}"/>
                </a:ext>
              </a:extLst>
            </p:cNvPr>
            <p:cNvCxnSpPr>
              <a:cxnSpLocks/>
              <a:endCxn id="13" idx="1"/>
            </p:cNvCxnSpPr>
            <p:nvPr/>
          </p:nvCxnSpPr>
          <p:spPr>
            <a:xfrm>
              <a:off x="981526" y="2912477"/>
              <a:ext cx="44592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B9B011F4-4960-3E43-82EC-F8EDC491D4DA}"/>
                </a:ext>
              </a:extLst>
            </p:cNvPr>
            <p:cNvCxnSpPr>
              <a:cxnSpLocks/>
              <a:endCxn id="20" idx="1"/>
            </p:cNvCxnSpPr>
            <p:nvPr/>
          </p:nvCxnSpPr>
          <p:spPr>
            <a:xfrm>
              <a:off x="981526" y="2455277"/>
              <a:ext cx="44592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942AD245-95DF-3148-8695-422C02313C0F}"/>
                </a:ext>
              </a:extLst>
            </p:cNvPr>
            <p:cNvCxnSpPr>
              <a:cxnSpLocks/>
              <a:endCxn id="17" idx="1"/>
            </p:cNvCxnSpPr>
            <p:nvPr/>
          </p:nvCxnSpPr>
          <p:spPr>
            <a:xfrm>
              <a:off x="989373" y="1892552"/>
              <a:ext cx="43807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752547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41</TotalTime>
  <Words>93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ene, Spencer</dc:creator>
  <cp:lastModifiedBy>demetrah10@gmail.com</cp:lastModifiedBy>
  <cp:revision>93</cp:revision>
  <dcterms:created xsi:type="dcterms:W3CDTF">2015-07-17T16:10:31Z</dcterms:created>
  <dcterms:modified xsi:type="dcterms:W3CDTF">2020-08-11T00:48:47Z</dcterms:modified>
</cp:coreProperties>
</file>